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10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BMPR1A</a:t>
            </a:r>
            <a:r>
              <a:rPr lang="en-GB" sz="1600" dirty="0" smtClean="0"/>
              <a:t> gene. A) Wild (Template</a:t>
            </a:r>
            <a:r>
              <a:rPr lang="en-US" sz="1600" dirty="0" smtClean="0"/>
              <a:t> 3mdy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3mdy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85786" y="785794"/>
            <a:ext cx="2729952" cy="21431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357818" y="201762"/>
            <a:ext cx="3000396" cy="2798610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85786" y="3357562"/>
            <a:ext cx="2786082" cy="25244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357818" y="3128984"/>
            <a:ext cx="3000396" cy="272705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54</cp:revision>
  <dcterms:created xsi:type="dcterms:W3CDTF">2018-05-10T07:33:24Z</dcterms:created>
  <dcterms:modified xsi:type="dcterms:W3CDTF">2018-05-29T06:52:15Z</dcterms:modified>
</cp:coreProperties>
</file>